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97" d="100"/>
          <a:sy n="97" d="100"/>
        </p:scale>
        <p:origin x="516" y="8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ABB965-AB54-46BA-BE0B-F4EEBBCBE1B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AF039A6-AE15-411C-AAB6-8B22B103C6A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92DCB5-5A2C-438D-BC30-8A9FB2C8AE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E79F7-98E5-4133-8AF7-B6C25AC18B9B}" type="datetimeFigureOut">
              <a:rPr lang="en-US" smtClean="0"/>
              <a:t>6/24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B46165-C727-4E44-8799-A554A8211C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70DEA3-A3A2-4AB7-B869-239CBDB147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86426A-6C64-4C06-AEDF-A63FF08614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61680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1D0CA3-B5CB-4035-93B3-B3B3D3E418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3349215-BAB5-4C3F-B5A0-11D5189A56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6448F3-1B1A-4735-8677-80C0BBADA6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E79F7-98E5-4133-8AF7-B6C25AC18B9B}" type="datetimeFigureOut">
              <a:rPr lang="en-US" smtClean="0"/>
              <a:t>6/24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AA23CD-341E-4EBB-B214-566926668B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5A3B28-D18E-440B-9770-5551D6D091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86426A-6C64-4C06-AEDF-A63FF08614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31490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9FC36F0-86DC-403C-97E7-82A92790C2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89CA75-F30A-49A2-91D8-1E99C1E217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3A51A7-EB45-4FBE-B3D9-516F089CC6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E79F7-98E5-4133-8AF7-B6C25AC18B9B}" type="datetimeFigureOut">
              <a:rPr lang="en-US" smtClean="0"/>
              <a:t>6/24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448639-44FF-4ADC-8EF3-DB0C04BCCD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B34614-6365-401D-BF6B-D0687CD69F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86426A-6C64-4C06-AEDF-A63FF08614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76487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ECD07B-735B-4B81-A4E5-3CC3EA3F24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18282E-71A1-4B20-BC59-AA41D17819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DF3B55-B344-490F-9DB0-38A5F1F93B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E79F7-98E5-4133-8AF7-B6C25AC18B9B}" type="datetimeFigureOut">
              <a:rPr lang="en-US" smtClean="0"/>
              <a:t>6/24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AD6675-D447-43C0-8D53-942426EDAB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4D9B82-FE73-4D2F-A4ED-290D4DF61B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86426A-6C64-4C06-AEDF-A63FF08614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4916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9120BA-556B-47FB-A1E1-B29322FC34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0C3420-C158-44E3-877C-29BF19DE44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A47C48-4F85-4367-9419-918D3AB6F0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E79F7-98E5-4133-8AF7-B6C25AC18B9B}" type="datetimeFigureOut">
              <a:rPr lang="en-US" smtClean="0"/>
              <a:t>6/24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81F41E-BFFB-4998-99FF-5A1D6A9FDF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5FBA4B-2DD6-4497-8F52-A62679920D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86426A-6C64-4C06-AEDF-A63FF08614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08365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885273-FE20-40A7-B9DB-4A14B47E7B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6D0A7E-2110-4566-A362-8685B124A9C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DF3FA5F-E54C-47FB-A3B8-6BD631A0C3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2FBDDC-E85F-4F1C-A953-0BE8F16C42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E79F7-98E5-4133-8AF7-B6C25AC18B9B}" type="datetimeFigureOut">
              <a:rPr lang="en-US" smtClean="0"/>
              <a:t>6/24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EECD7C-AFB6-4801-BB5D-CAC64ECBBA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990A4EB-CBB8-4297-AC78-4604977E87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86426A-6C64-4C06-AEDF-A63FF08614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60391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7A8B77-1F00-4EEE-A0F3-55D6EBC5D0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9FB8ED1-C732-4EF7-87B0-D858558D43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41B0781-13F0-4814-91C1-1A5F758C3D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537573D-8E6A-4EE2-AC79-C4379BB6F6F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B97BC3D-87AA-4F3D-9D56-133FE584752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8C9F959-6431-4BA6-AE90-943B01B113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E79F7-98E5-4133-8AF7-B6C25AC18B9B}" type="datetimeFigureOut">
              <a:rPr lang="en-US" smtClean="0"/>
              <a:t>6/24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A263144-6461-46E3-9639-1F36BFC771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AAB990C-7FAE-4162-9B7D-36C59B9878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86426A-6C64-4C06-AEDF-A63FF08614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84519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7BE036-E9C7-4E9C-9E88-7EBE92A02A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21B4F49-C533-422F-9EA3-A812DD65C6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E79F7-98E5-4133-8AF7-B6C25AC18B9B}" type="datetimeFigureOut">
              <a:rPr lang="en-US" smtClean="0"/>
              <a:t>6/24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A009778-4558-4751-91E0-B06F007821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961518C-B38D-48F8-99CB-A89461CD5F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86426A-6C64-4C06-AEDF-A63FF08614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41868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5FD0212-0A37-412A-B12D-CECEB2E299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E79F7-98E5-4133-8AF7-B6C25AC18B9B}" type="datetimeFigureOut">
              <a:rPr lang="en-US" smtClean="0"/>
              <a:t>6/24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78E2377-12D7-4E2A-AFD9-4368472A77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FD4EE05-10BB-4138-9A6B-A8E093851C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86426A-6C64-4C06-AEDF-A63FF08614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7212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B08B31-09BC-4E1E-B954-D4149C5941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340DBA-E2C2-4542-99B2-B86A005AE80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06A397C-2C37-4F67-BDA4-A4A59DA6A0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A6895F-08F0-43F6-B816-89F698242A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E79F7-98E5-4133-8AF7-B6C25AC18B9B}" type="datetimeFigureOut">
              <a:rPr lang="en-US" smtClean="0"/>
              <a:t>6/24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DD55A2-C691-4EDF-80B4-CC8ABB5FA2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6D5FCA9-BB58-423E-BCA7-E6900158CF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86426A-6C64-4C06-AEDF-A63FF08614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61556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0D490C-F596-4C2B-B503-5AFD79BBB0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E30F5E7-FAC7-424D-B8BE-9E9C7554E4E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6573115-C561-47C7-95F1-F4AF824CD24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FE1FBF-0E34-4236-AE71-608FDD6630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1E79F7-98E5-4133-8AF7-B6C25AC18B9B}" type="datetimeFigureOut">
              <a:rPr lang="en-US" smtClean="0"/>
              <a:t>6/24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3762EA-AF60-4701-AD58-71A1528994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0017231-8564-42B2-A697-D3CBCA6165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86426A-6C64-4C06-AEDF-A63FF08614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73336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143B9E3-B826-4C57-A765-91BA04551F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DCDB922-A38D-4C5D-BF96-1AC23F8699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988836-B48A-4E07-BE6B-8CAF22344D4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1E79F7-98E5-4133-8AF7-B6C25AC18B9B}" type="datetimeFigureOut">
              <a:rPr lang="en-US" smtClean="0"/>
              <a:t>6/24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FB6B9C-2CF0-4100-9C88-7844173D24B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1967E2-437C-4E31-A089-37B93E8D168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86426A-6C64-4C06-AEDF-A63FF08614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10130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6" name="Group 45">
            <a:extLst>
              <a:ext uri="{FF2B5EF4-FFF2-40B4-BE49-F238E27FC236}">
                <a16:creationId xmlns:a16="http://schemas.microsoft.com/office/drawing/2014/main" id="{50F4B7E5-CD3F-41EA-ACD3-6174AD8546C1}"/>
              </a:ext>
            </a:extLst>
          </p:cNvPr>
          <p:cNvGrpSpPr/>
          <p:nvPr/>
        </p:nvGrpSpPr>
        <p:grpSpPr>
          <a:xfrm>
            <a:off x="2545218" y="-124984"/>
            <a:ext cx="7766783" cy="6670506"/>
            <a:chOff x="2545218" y="-124984"/>
            <a:chExt cx="7766783" cy="6670506"/>
          </a:xfrm>
        </p:grpSpPr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id="{7A8A4C9D-D56D-4EE2-9BE7-0048A8E686FA}"/>
                </a:ext>
              </a:extLst>
            </p:cNvPr>
            <p:cNvGrpSpPr/>
            <p:nvPr/>
          </p:nvGrpSpPr>
          <p:grpSpPr>
            <a:xfrm>
              <a:off x="2545218" y="-124984"/>
              <a:ext cx="6763240" cy="6335010"/>
              <a:chOff x="2341289" y="-124984"/>
              <a:chExt cx="7310149" cy="6858000"/>
            </a:xfrm>
          </p:grpSpPr>
          <p:sp>
            <p:nvSpPr>
              <p:cNvPr id="7" name="AutoShape 3">
                <a:extLst>
                  <a:ext uri="{FF2B5EF4-FFF2-40B4-BE49-F238E27FC236}">
                    <a16:creationId xmlns:a16="http://schemas.microsoft.com/office/drawing/2014/main" id="{F80A0E49-3CAF-408E-976D-28BC23060B11}"/>
                  </a:ext>
                </a:extLst>
              </p:cNvPr>
              <p:cNvSpPr>
                <a:spLocks noChangeAspect="1" noChangeArrowheads="1" noTextEdit="1"/>
              </p:cNvSpPr>
              <p:nvPr/>
            </p:nvSpPr>
            <p:spPr bwMode="auto">
              <a:xfrm>
                <a:off x="2341289" y="-124984"/>
                <a:ext cx="5299075" cy="6858000"/>
              </a:xfrm>
              <a:prstGeom prst="rect">
                <a:avLst/>
              </a:prstGeom>
              <a:noFill/>
              <a:ln w="19050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 sz="1400" dirty="0"/>
              </a:p>
            </p:txBody>
          </p:sp>
          <p:sp>
            <p:nvSpPr>
              <p:cNvPr id="8" name="Freeform 5">
                <a:extLst>
                  <a:ext uri="{FF2B5EF4-FFF2-40B4-BE49-F238E27FC236}">
                    <a16:creationId xmlns:a16="http://schemas.microsoft.com/office/drawing/2014/main" id="{13427457-BB50-4A98-BD93-1C83C2A6D696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657202" y="569913"/>
                <a:ext cx="4414838" cy="5910263"/>
              </a:xfrm>
              <a:custGeom>
                <a:avLst/>
                <a:gdLst>
                  <a:gd name="T0" fmla="*/ 4259 w 4259"/>
                  <a:gd name="T1" fmla="*/ 0 h 5687"/>
                  <a:gd name="T2" fmla="*/ 0 w 4259"/>
                  <a:gd name="T3" fmla="*/ 0 h 5687"/>
                  <a:gd name="T4" fmla="*/ 0 w 4259"/>
                  <a:gd name="T5" fmla="*/ 2993 h 5687"/>
                  <a:gd name="T6" fmla="*/ 852 w 4259"/>
                  <a:gd name="T7" fmla="*/ 2993 h 5687"/>
                  <a:gd name="T8" fmla="*/ 4259 w 4259"/>
                  <a:gd name="T9" fmla="*/ 299 h 5687"/>
                  <a:gd name="T10" fmla="*/ 852 w 4259"/>
                  <a:gd name="T11" fmla="*/ 299 h 5687"/>
                  <a:gd name="T12" fmla="*/ 852 w 4259"/>
                  <a:gd name="T13" fmla="*/ 5687 h 5687"/>
                  <a:gd name="T14" fmla="*/ 4259 w 4259"/>
                  <a:gd name="T15" fmla="*/ 5687 h 5687"/>
                  <a:gd name="T16" fmla="*/ 4259 w 4259"/>
                  <a:gd name="T17" fmla="*/ 598 h 5687"/>
                  <a:gd name="T18" fmla="*/ 852 w 4259"/>
                  <a:gd name="T19" fmla="*/ 598 h 5687"/>
                  <a:gd name="T20" fmla="*/ 4259 w 4259"/>
                  <a:gd name="T21" fmla="*/ 897 h 5687"/>
                  <a:gd name="T22" fmla="*/ 852 w 4259"/>
                  <a:gd name="T23" fmla="*/ 897 h 5687"/>
                  <a:gd name="T24" fmla="*/ 4259 w 4259"/>
                  <a:gd name="T25" fmla="*/ 1197 h 5687"/>
                  <a:gd name="T26" fmla="*/ 852 w 4259"/>
                  <a:gd name="T27" fmla="*/ 1197 h 5687"/>
                  <a:gd name="T28" fmla="*/ 4259 w 4259"/>
                  <a:gd name="T29" fmla="*/ 1496 h 5687"/>
                  <a:gd name="T30" fmla="*/ 852 w 4259"/>
                  <a:gd name="T31" fmla="*/ 1496 h 5687"/>
                  <a:gd name="T32" fmla="*/ 1704 w 4259"/>
                  <a:gd name="T33" fmla="*/ 2431 h 5687"/>
                  <a:gd name="T34" fmla="*/ 852 w 4259"/>
                  <a:gd name="T35" fmla="*/ 2431 h 5687"/>
                  <a:gd name="T36" fmla="*/ 2556 w 4259"/>
                  <a:gd name="T37" fmla="*/ 2170 h 5687"/>
                  <a:gd name="T38" fmla="*/ 1704 w 4259"/>
                  <a:gd name="T39" fmla="*/ 2170 h 5687"/>
                  <a:gd name="T40" fmla="*/ 1704 w 4259"/>
                  <a:gd name="T41" fmla="*/ 2693 h 5687"/>
                  <a:gd name="T42" fmla="*/ 4259 w 4259"/>
                  <a:gd name="T43" fmla="*/ 2693 h 5687"/>
                  <a:gd name="T44" fmla="*/ 3408 w 4259"/>
                  <a:gd name="T45" fmla="*/ 1945 h 5687"/>
                  <a:gd name="T46" fmla="*/ 2556 w 4259"/>
                  <a:gd name="T47" fmla="*/ 1945 h 5687"/>
                  <a:gd name="T48" fmla="*/ 2556 w 4259"/>
                  <a:gd name="T49" fmla="*/ 2394 h 5687"/>
                  <a:gd name="T50" fmla="*/ 4259 w 4259"/>
                  <a:gd name="T51" fmla="*/ 2394 h 5687"/>
                  <a:gd name="T52" fmla="*/ 4259 w 4259"/>
                  <a:gd name="T53" fmla="*/ 1795 h 5687"/>
                  <a:gd name="T54" fmla="*/ 3408 w 4259"/>
                  <a:gd name="T55" fmla="*/ 1795 h 5687"/>
                  <a:gd name="T56" fmla="*/ 3408 w 4259"/>
                  <a:gd name="T57" fmla="*/ 2095 h 5687"/>
                  <a:gd name="T58" fmla="*/ 4259 w 4259"/>
                  <a:gd name="T59" fmla="*/ 2095 h 5687"/>
                  <a:gd name="T60" fmla="*/ 4259 w 4259"/>
                  <a:gd name="T61" fmla="*/ 2993 h 5687"/>
                  <a:gd name="T62" fmla="*/ 852 w 4259"/>
                  <a:gd name="T63" fmla="*/ 2993 h 5687"/>
                  <a:gd name="T64" fmla="*/ 2556 w 4259"/>
                  <a:gd name="T65" fmla="*/ 3666 h 5687"/>
                  <a:gd name="T66" fmla="*/ 852 w 4259"/>
                  <a:gd name="T67" fmla="*/ 3666 h 5687"/>
                  <a:gd name="T68" fmla="*/ 3408 w 4259"/>
                  <a:gd name="T69" fmla="*/ 3442 h 5687"/>
                  <a:gd name="T70" fmla="*/ 2556 w 4259"/>
                  <a:gd name="T71" fmla="*/ 3442 h 5687"/>
                  <a:gd name="T72" fmla="*/ 2556 w 4259"/>
                  <a:gd name="T73" fmla="*/ 3891 h 5687"/>
                  <a:gd name="T74" fmla="*/ 4259 w 4259"/>
                  <a:gd name="T75" fmla="*/ 3891 h 5687"/>
                  <a:gd name="T76" fmla="*/ 4259 w 4259"/>
                  <a:gd name="T77" fmla="*/ 3292 h 5687"/>
                  <a:gd name="T78" fmla="*/ 3408 w 4259"/>
                  <a:gd name="T79" fmla="*/ 3292 h 5687"/>
                  <a:gd name="T80" fmla="*/ 3408 w 4259"/>
                  <a:gd name="T81" fmla="*/ 3591 h 5687"/>
                  <a:gd name="T82" fmla="*/ 4259 w 4259"/>
                  <a:gd name="T83" fmla="*/ 3591 h 5687"/>
                  <a:gd name="T84" fmla="*/ 4259 w 4259"/>
                  <a:gd name="T85" fmla="*/ 4190 h 5687"/>
                  <a:gd name="T86" fmla="*/ 852 w 4259"/>
                  <a:gd name="T87" fmla="*/ 4190 h 5687"/>
                  <a:gd name="T88" fmla="*/ 4259 w 4259"/>
                  <a:gd name="T89" fmla="*/ 4489 h 5687"/>
                  <a:gd name="T90" fmla="*/ 852 w 4259"/>
                  <a:gd name="T91" fmla="*/ 4489 h 5687"/>
                  <a:gd name="T92" fmla="*/ 3408 w 4259"/>
                  <a:gd name="T93" fmla="*/ 4938 h 5687"/>
                  <a:gd name="T94" fmla="*/ 852 w 4259"/>
                  <a:gd name="T95" fmla="*/ 4938 h 5687"/>
                  <a:gd name="T96" fmla="*/ 4259 w 4259"/>
                  <a:gd name="T97" fmla="*/ 4789 h 5687"/>
                  <a:gd name="T98" fmla="*/ 3408 w 4259"/>
                  <a:gd name="T99" fmla="*/ 4789 h 5687"/>
                  <a:gd name="T100" fmla="*/ 3408 w 4259"/>
                  <a:gd name="T101" fmla="*/ 5088 h 5687"/>
                  <a:gd name="T102" fmla="*/ 4259 w 4259"/>
                  <a:gd name="T103" fmla="*/ 5088 h 5687"/>
                  <a:gd name="T104" fmla="*/ 4259 w 4259"/>
                  <a:gd name="T105" fmla="*/ 5387 h 5687"/>
                  <a:gd name="T106" fmla="*/ 852 w 4259"/>
                  <a:gd name="T107" fmla="*/ 5387 h 56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</a:cxnLst>
                <a:rect l="0" t="0" r="r" b="b"/>
                <a:pathLst>
                  <a:path w="4259" h="5687">
                    <a:moveTo>
                      <a:pt x="4259" y="0"/>
                    </a:moveTo>
                    <a:lnTo>
                      <a:pt x="0" y="0"/>
                    </a:lnTo>
                    <a:lnTo>
                      <a:pt x="0" y="2993"/>
                    </a:lnTo>
                    <a:lnTo>
                      <a:pt x="852" y="2993"/>
                    </a:lnTo>
                    <a:moveTo>
                      <a:pt x="4259" y="299"/>
                    </a:moveTo>
                    <a:lnTo>
                      <a:pt x="852" y="299"/>
                    </a:lnTo>
                    <a:lnTo>
                      <a:pt x="852" y="5687"/>
                    </a:lnTo>
                    <a:lnTo>
                      <a:pt x="4259" y="5687"/>
                    </a:lnTo>
                    <a:moveTo>
                      <a:pt x="4259" y="598"/>
                    </a:moveTo>
                    <a:lnTo>
                      <a:pt x="852" y="598"/>
                    </a:lnTo>
                    <a:moveTo>
                      <a:pt x="4259" y="897"/>
                    </a:moveTo>
                    <a:lnTo>
                      <a:pt x="852" y="897"/>
                    </a:lnTo>
                    <a:moveTo>
                      <a:pt x="4259" y="1197"/>
                    </a:moveTo>
                    <a:lnTo>
                      <a:pt x="852" y="1197"/>
                    </a:lnTo>
                    <a:moveTo>
                      <a:pt x="4259" y="1496"/>
                    </a:moveTo>
                    <a:lnTo>
                      <a:pt x="852" y="1496"/>
                    </a:lnTo>
                    <a:moveTo>
                      <a:pt x="1704" y="2431"/>
                    </a:moveTo>
                    <a:lnTo>
                      <a:pt x="852" y="2431"/>
                    </a:lnTo>
                    <a:moveTo>
                      <a:pt x="2556" y="2170"/>
                    </a:moveTo>
                    <a:lnTo>
                      <a:pt x="1704" y="2170"/>
                    </a:lnTo>
                    <a:lnTo>
                      <a:pt x="1704" y="2693"/>
                    </a:lnTo>
                    <a:lnTo>
                      <a:pt x="4259" y="2693"/>
                    </a:lnTo>
                    <a:moveTo>
                      <a:pt x="3408" y="1945"/>
                    </a:moveTo>
                    <a:lnTo>
                      <a:pt x="2556" y="1945"/>
                    </a:lnTo>
                    <a:lnTo>
                      <a:pt x="2556" y="2394"/>
                    </a:lnTo>
                    <a:lnTo>
                      <a:pt x="4259" y="2394"/>
                    </a:lnTo>
                    <a:moveTo>
                      <a:pt x="4259" y="1795"/>
                    </a:moveTo>
                    <a:lnTo>
                      <a:pt x="3408" y="1795"/>
                    </a:lnTo>
                    <a:lnTo>
                      <a:pt x="3408" y="2095"/>
                    </a:lnTo>
                    <a:lnTo>
                      <a:pt x="4259" y="2095"/>
                    </a:lnTo>
                    <a:moveTo>
                      <a:pt x="4259" y="2993"/>
                    </a:moveTo>
                    <a:lnTo>
                      <a:pt x="852" y="2993"/>
                    </a:lnTo>
                    <a:moveTo>
                      <a:pt x="2556" y="3666"/>
                    </a:moveTo>
                    <a:lnTo>
                      <a:pt x="852" y="3666"/>
                    </a:lnTo>
                    <a:moveTo>
                      <a:pt x="3408" y="3442"/>
                    </a:moveTo>
                    <a:lnTo>
                      <a:pt x="2556" y="3442"/>
                    </a:lnTo>
                    <a:lnTo>
                      <a:pt x="2556" y="3891"/>
                    </a:lnTo>
                    <a:lnTo>
                      <a:pt x="4259" y="3891"/>
                    </a:lnTo>
                    <a:moveTo>
                      <a:pt x="4259" y="3292"/>
                    </a:moveTo>
                    <a:lnTo>
                      <a:pt x="3408" y="3292"/>
                    </a:lnTo>
                    <a:lnTo>
                      <a:pt x="3408" y="3591"/>
                    </a:lnTo>
                    <a:lnTo>
                      <a:pt x="4259" y="3591"/>
                    </a:lnTo>
                    <a:moveTo>
                      <a:pt x="4259" y="4190"/>
                    </a:moveTo>
                    <a:lnTo>
                      <a:pt x="852" y="4190"/>
                    </a:lnTo>
                    <a:moveTo>
                      <a:pt x="4259" y="4489"/>
                    </a:moveTo>
                    <a:lnTo>
                      <a:pt x="852" y="4489"/>
                    </a:lnTo>
                    <a:moveTo>
                      <a:pt x="3408" y="4938"/>
                    </a:moveTo>
                    <a:lnTo>
                      <a:pt x="852" y="4938"/>
                    </a:lnTo>
                    <a:moveTo>
                      <a:pt x="4259" y="4789"/>
                    </a:moveTo>
                    <a:lnTo>
                      <a:pt x="3408" y="4789"/>
                    </a:lnTo>
                    <a:lnTo>
                      <a:pt x="3408" y="5088"/>
                    </a:lnTo>
                    <a:lnTo>
                      <a:pt x="4259" y="5088"/>
                    </a:lnTo>
                    <a:moveTo>
                      <a:pt x="4259" y="5387"/>
                    </a:moveTo>
                    <a:lnTo>
                      <a:pt x="852" y="5387"/>
                    </a:lnTo>
                  </a:path>
                </a:pathLst>
              </a:custGeom>
              <a:ln w="19050"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9" name="Rectangle 6">
                <a:extLst>
                  <a:ext uri="{FF2B5EF4-FFF2-40B4-BE49-F238E27FC236}">
                    <a16:creationId xmlns:a16="http://schemas.microsoft.com/office/drawing/2014/main" id="{F909E892-62A3-4E7B-8FE2-123CA2B110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23067" y="461963"/>
                <a:ext cx="1147763" cy="2159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lang="en-US" sz="1400" i="1" dirty="0">
                    <a:latin typeface="+mn-lt"/>
                  </a:rPr>
                  <a:t>Bonasa</a:t>
                </a:r>
                <a:r>
                  <a:rPr kumimoji="0" lang="en-US" altLang="en-US" sz="1400" b="0" i="0" u="none" strike="noStrike" cap="none" normalizeH="0" baseline="0" dirty="0">
                    <a:solidFill>
                      <a:srgbClr val="000000"/>
                    </a:solidFill>
                    <a:effectLst/>
                    <a:latin typeface="+mn-lt"/>
                  </a:rPr>
                  <a:t> </a:t>
                </a:r>
                <a:r>
                  <a:rPr kumimoji="0" lang="en-US" altLang="en-US" sz="1400" b="0" i="0" u="none" strike="noStrike" cap="none" normalizeH="0" baseline="0" dirty="0" err="1">
                    <a:solidFill>
                      <a:srgbClr val="000000"/>
                    </a:solidFill>
                    <a:effectLst/>
                    <a:latin typeface="+mn-lt"/>
                  </a:rPr>
                  <a:t>bonasia</a:t>
                </a:r>
                <a:endParaRPr kumimoji="0" lang="en-US" altLang="en-US" sz="1400" b="0" i="0" u="none" strike="noStrike" cap="none" normalizeH="0" baseline="0" dirty="0"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0" name="Rectangle 7">
                <a:extLst>
                  <a:ext uri="{FF2B5EF4-FFF2-40B4-BE49-F238E27FC236}">
                    <a16:creationId xmlns:a16="http://schemas.microsoft.com/office/drawing/2014/main" id="{814C6669-FF87-4585-848A-23310F2829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42803" y="762662"/>
                <a:ext cx="2508635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H1 (AK, AB, MTB, MN, ND, SD, ON)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1" name="Rectangle 8">
                <a:extLst>
                  <a:ext uri="{FF2B5EF4-FFF2-40B4-BE49-F238E27FC236}">
                    <a16:creationId xmlns:a16="http://schemas.microsoft.com/office/drawing/2014/main" id="{391A874E-F953-4588-B9EB-2AAB3E5173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42803" y="1083330"/>
                <a:ext cx="1836978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H2 (AB, MB, MN, ND, WI)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2" name="Rectangle 9">
                <a:extLst>
                  <a:ext uri="{FF2B5EF4-FFF2-40B4-BE49-F238E27FC236}">
                    <a16:creationId xmlns:a16="http://schemas.microsoft.com/office/drawing/2014/main" id="{F80C97EC-B967-4B10-ADE4-F942C979F2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42803" y="1394480"/>
                <a:ext cx="637995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H3 MTB)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3" name="Rectangle 10">
                <a:extLst>
                  <a:ext uri="{FF2B5EF4-FFF2-40B4-BE49-F238E27FC236}">
                    <a16:creationId xmlns:a16="http://schemas.microsoft.com/office/drawing/2014/main" id="{C706F768-7CAB-4AA8-894E-27127CBCA93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42803" y="1705630"/>
                <a:ext cx="69249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H4 (MTB)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4" name="Rectangle 11">
                <a:extLst>
                  <a:ext uri="{FF2B5EF4-FFF2-40B4-BE49-F238E27FC236}">
                    <a16:creationId xmlns:a16="http://schemas.microsoft.com/office/drawing/2014/main" id="{E79D9496-3191-4262-9CF6-F0A0E12AEE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42803" y="2016780"/>
                <a:ext cx="69249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H5 (MTB)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5" name="Rectangle 12">
                <a:extLst>
                  <a:ext uri="{FF2B5EF4-FFF2-40B4-BE49-F238E27FC236}">
                    <a16:creationId xmlns:a16="http://schemas.microsoft.com/office/drawing/2014/main" id="{32FAB6F9-14C5-4CEB-AC57-92923EF7E4D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42803" y="2327930"/>
                <a:ext cx="1155701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H6 (WA, MY, ID)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6" name="Rectangle 13">
                <a:extLst>
                  <a:ext uri="{FF2B5EF4-FFF2-40B4-BE49-F238E27FC236}">
                    <a16:creationId xmlns:a16="http://schemas.microsoft.com/office/drawing/2014/main" id="{7E7AD026-0968-4C09-927D-68EE9208BA6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42803" y="2639080"/>
                <a:ext cx="508152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H9 (ID)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7" name="Rectangle 14">
                <a:extLst>
                  <a:ext uri="{FF2B5EF4-FFF2-40B4-BE49-F238E27FC236}">
                    <a16:creationId xmlns:a16="http://schemas.microsoft.com/office/drawing/2014/main" id="{970E3F61-21A3-47E0-9032-6785B7EA87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42803" y="2950230"/>
                <a:ext cx="609013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H8 (WA)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8" name="Rectangle 15">
                <a:extLst>
                  <a:ext uri="{FF2B5EF4-FFF2-40B4-BE49-F238E27FC236}">
                    <a16:creationId xmlns:a16="http://schemas.microsoft.com/office/drawing/2014/main" id="{877ED71A-1FF6-4529-91D9-00C7BC8C45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42803" y="3261380"/>
                <a:ext cx="609013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H7 (WA)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19" name="Rectangle 16">
                <a:extLst>
                  <a:ext uri="{FF2B5EF4-FFF2-40B4-BE49-F238E27FC236}">
                    <a16:creationId xmlns:a16="http://schemas.microsoft.com/office/drawing/2014/main" id="{CF8D5551-1E37-4D8A-B512-7AA45FFB228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42803" y="3572530"/>
                <a:ext cx="670055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H10 (ND)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20" name="Rectangle 17">
                <a:extLst>
                  <a:ext uri="{FF2B5EF4-FFF2-40B4-BE49-F238E27FC236}">
                    <a16:creationId xmlns:a16="http://schemas.microsoft.com/office/drawing/2014/main" id="{CA9F21DD-10F8-47C5-AF3B-E16CA9D6A1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42803" y="3882092"/>
                <a:ext cx="1572546" cy="4308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H11 (MN, WI, PN, VT)</a:t>
                </a:r>
                <a:br>
                  <a:rPr kumimoji="0" lang="en-US" alt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</a:b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21" name="Rectangle 18">
                <a:extLst>
                  <a:ext uri="{FF2B5EF4-FFF2-40B4-BE49-F238E27FC236}">
                    <a16:creationId xmlns:a16="http://schemas.microsoft.com/office/drawing/2014/main" id="{DDC627D9-415D-429A-A7DE-A23DA07089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42803" y="4194830"/>
                <a:ext cx="64921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H15 (WI)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22" name="Rectangle 19">
                <a:extLst>
                  <a:ext uri="{FF2B5EF4-FFF2-40B4-BE49-F238E27FC236}">
                    <a16:creationId xmlns:a16="http://schemas.microsoft.com/office/drawing/2014/main" id="{297A4ED0-C9DF-47FE-B829-1BE1D22266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42803" y="4504392"/>
                <a:ext cx="647613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H17 (TN)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23" name="Rectangle 20">
                <a:extLst>
                  <a:ext uri="{FF2B5EF4-FFF2-40B4-BE49-F238E27FC236}">
                    <a16:creationId xmlns:a16="http://schemas.microsoft.com/office/drawing/2014/main" id="{2F0D458E-F86A-49C6-8991-9514704444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42803" y="4815542"/>
                <a:ext cx="71333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H12 (MN)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24" name="Rectangle 21">
                <a:extLst>
                  <a:ext uri="{FF2B5EF4-FFF2-40B4-BE49-F238E27FC236}">
                    <a16:creationId xmlns:a16="http://schemas.microsoft.com/office/drawing/2014/main" id="{6F8FA2E3-98F9-4815-BE4E-9E1ED33A3D4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42803" y="5128280"/>
                <a:ext cx="71333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H13 (MN)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25" name="Rectangle 22">
                <a:extLst>
                  <a:ext uri="{FF2B5EF4-FFF2-40B4-BE49-F238E27FC236}">
                    <a16:creationId xmlns:a16="http://schemas.microsoft.com/office/drawing/2014/main" id="{A997181D-E708-4018-A11B-904C5A456D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42803" y="5437842"/>
                <a:ext cx="233916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H14 (KY, TN, NC, QC, NS, PN, VT)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26" name="Rectangle 23">
                <a:extLst>
                  <a:ext uri="{FF2B5EF4-FFF2-40B4-BE49-F238E27FC236}">
                    <a16:creationId xmlns:a16="http://schemas.microsoft.com/office/drawing/2014/main" id="{DD38D8F1-E19D-4B0E-858E-F1473B18088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42803" y="5750580"/>
                <a:ext cx="655629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H18 (NC)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27" name="Rectangle 24">
                <a:extLst>
                  <a:ext uri="{FF2B5EF4-FFF2-40B4-BE49-F238E27FC236}">
                    <a16:creationId xmlns:a16="http://schemas.microsoft.com/office/drawing/2014/main" id="{34375BAA-C815-4B1A-96D1-BFD6FC0E3AC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42803" y="6063318"/>
                <a:ext cx="64921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H16 (WI)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28" name="Rectangle 25">
                <a:extLst>
                  <a:ext uri="{FF2B5EF4-FFF2-40B4-BE49-F238E27FC236}">
                    <a16:creationId xmlns:a16="http://schemas.microsoft.com/office/drawing/2014/main" id="{D46DEB4E-F75E-4DB0-ACD3-6C3E10A6761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42803" y="6372880"/>
                <a:ext cx="641201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H19 (NF)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29" name="Rectangle 26">
                <a:extLst>
                  <a:ext uri="{FF2B5EF4-FFF2-40B4-BE49-F238E27FC236}">
                    <a16:creationId xmlns:a16="http://schemas.microsoft.com/office/drawing/2014/main" id="{32BCD213-8BE3-43EB-9291-553630BE97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14502" y="2886504"/>
                <a:ext cx="182742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52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30" name="Rectangle 27">
                <a:extLst>
                  <a:ext uri="{FF2B5EF4-FFF2-40B4-BE49-F238E27FC236}">
                    <a16:creationId xmlns:a16="http://schemas.microsoft.com/office/drawing/2014/main" id="{9C2A2803-156F-4D52-B6F9-70AD3DE785B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22552" y="2615041"/>
                <a:ext cx="182742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85</a:t>
                </a:r>
                <a:endParaRPr kumimoji="0" lang="en-US" altLang="en-US" sz="1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31" name="Rectangle 28">
                <a:extLst>
                  <a:ext uri="{FF2B5EF4-FFF2-40B4-BE49-F238E27FC236}">
                    <a16:creationId xmlns:a16="http://schemas.microsoft.com/office/drawing/2014/main" id="{F0B45B1C-8863-4F92-A257-FDE1989AF13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05202" y="2380091"/>
                <a:ext cx="182742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71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32" name="Rectangle 29">
                <a:extLst>
                  <a:ext uri="{FF2B5EF4-FFF2-40B4-BE49-F238E27FC236}">
                    <a16:creationId xmlns:a16="http://schemas.microsoft.com/office/drawing/2014/main" id="{C69B63C0-70F9-4EFE-BBC4-BADBA245F5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84402" y="4162623"/>
                <a:ext cx="182742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58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33" name="Rectangle 30">
                <a:extLst>
                  <a:ext uri="{FF2B5EF4-FFF2-40B4-BE49-F238E27FC236}">
                    <a16:creationId xmlns:a16="http://schemas.microsoft.com/office/drawing/2014/main" id="{71AD74DA-2D4A-43C3-93B7-DC4916FB556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05202" y="3930848"/>
                <a:ext cx="182742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53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  <p:sp>
            <p:nvSpPr>
              <p:cNvPr id="34" name="Rectangle 31">
                <a:extLst>
                  <a:ext uri="{FF2B5EF4-FFF2-40B4-BE49-F238E27FC236}">
                    <a16:creationId xmlns:a16="http://schemas.microsoft.com/office/drawing/2014/main" id="{ECE0C4BB-EFAB-4C5B-96A9-EB6AF23A43E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27314" y="5497085"/>
                <a:ext cx="182742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</a:rPr>
                  <a:t>96</a:t>
                </a:r>
                <a:endParaRPr kumimoji="0" lang="en-US" altLang="en-US" sz="14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</a:endParaRPr>
              </a:p>
            </p:txBody>
          </p:sp>
        </p:grp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8BA42DD3-6228-4887-B778-1D3E396A8008}"/>
                </a:ext>
              </a:extLst>
            </p:cNvPr>
            <p:cNvSpPr txBox="1"/>
            <p:nvPr/>
          </p:nvSpPr>
          <p:spPr>
            <a:xfrm>
              <a:off x="3797046" y="6176190"/>
              <a:ext cx="38743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Neighbor-joining Tree of Haplotypes </a:t>
              </a:r>
            </a:p>
          </p:txBody>
        </p:sp>
        <p:sp>
          <p:nvSpPr>
            <p:cNvPr id="40" name="Right Brace 39">
              <a:extLst>
                <a:ext uri="{FF2B5EF4-FFF2-40B4-BE49-F238E27FC236}">
                  <a16:creationId xmlns:a16="http://schemas.microsoft.com/office/drawing/2014/main" id="{28535753-CAA8-431C-B5A4-0F871B973796}"/>
                </a:ext>
              </a:extLst>
            </p:cNvPr>
            <p:cNvSpPr/>
            <p:nvPr/>
          </p:nvSpPr>
          <p:spPr>
            <a:xfrm>
              <a:off x="8147982" y="2189054"/>
              <a:ext cx="94775" cy="1008696"/>
            </a:xfrm>
            <a:prstGeom prst="rightBrac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AC337CAD-90D9-4919-8119-FEBE0444C8B4}"/>
                </a:ext>
              </a:extLst>
            </p:cNvPr>
            <p:cNvSpPr txBox="1"/>
            <p:nvPr/>
          </p:nvSpPr>
          <p:spPr>
            <a:xfrm>
              <a:off x="8251096" y="2518498"/>
              <a:ext cx="77328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Group 1</a:t>
              </a:r>
            </a:p>
          </p:txBody>
        </p:sp>
        <p:sp>
          <p:nvSpPr>
            <p:cNvPr id="42" name="Right Brace 41">
              <a:extLst>
                <a:ext uri="{FF2B5EF4-FFF2-40B4-BE49-F238E27FC236}">
                  <a16:creationId xmlns:a16="http://schemas.microsoft.com/office/drawing/2014/main" id="{74B1280C-08E8-4910-BD84-3347D2D16143}"/>
                </a:ext>
              </a:extLst>
            </p:cNvPr>
            <p:cNvSpPr/>
            <p:nvPr/>
          </p:nvSpPr>
          <p:spPr>
            <a:xfrm>
              <a:off x="9367666" y="5013622"/>
              <a:ext cx="157882" cy="426729"/>
            </a:xfrm>
            <a:prstGeom prst="rightBrac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80A4EB83-E152-41B9-9950-2537E327FE7E}"/>
                </a:ext>
              </a:extLst>
            </p:cNvPr>
            <p:cNvSpPr txBox="1"/>
            <p:nvPr/>
          </p:nvSpPr>
          <p:spPr>
            <a:xfrm>
              <a:off x="9538712" y="5074487"/>
              <a:ext cx="77328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Group 3</a:t>
              </a:r>
            </a:p>
          </p:txBody>
        </p:sp>
        <p:sp>
          <p:nvSpPr>
            <p:cNvPr id="44" name="Right Brace 43">
              <a:extLst>
                <a:ext uri="{FF2B5EF4-FFF2-40B4-BE49-F238E27FC236}">
                  <a16:creationId xmlns:a16="http://schemas.microsoft.com/office/drawing/2014/main" id="{E1C21A1E-DCE4-4AEA-9F5A-D2C3C8196322}"/>
                </a:ext>
              </a:extLst>
            </p:cNvPr>
            <p:cNvSpPr/>
            <p:nvPr/>
          </p:nvSpPr>
          <p:spPr>
            <a:xfrm>
              <a:off x="8559617" y="3646411"/>
              <a:ext cx="171046" cy="655874"/>
            </a:xfrm>
            <a:prstGeom prst="rightBrac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8D6CD3E2-5AC0-4EB8-B443-2D9AAD4E3306}"/>
                </a:ext>
              </a:extLst>
            </p:cNvPr>
            <p:cNvSpPr txBox="1"/>
            <p:nvPr/>
          </p:nvSpPr>
          <p:spPr>
            <a:xfrm>
              <a:off x="8730663" y="3792790"/>
              <a:ext cx="77328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Group 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6506829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2</TotalTime>
  <Words>135</Words>
  <Application>Microsoft Office PowerPoint</Application>
  <PresentationFormat>Widescreen</PresentationFormat>
  <Paragraphs>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dney Honeycutt</dc:creator>
  <cp:lastModifiedBy>Rodney Honeycutt</cp:lastModifiedBy>
  <cp:revision>4</cp:revision>
  <dcterms:created xsi:type="dcterms:W3CDTF">2019-06-24T16:36:50Z</dcterms:created>
  <dcterms:modified xsi:type="dcterms:W3CDTF">2019-06-24T18:29:19Z</dcterms:modified>
</cp:coreProperties>
</file>